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69" r:id="rId2"/>
  </p:sldIdLst>
  <p:sldSz cx="9144000" cy="77406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03"/>
    <p:restoredTop sz="89252"/>
  </p:normalViewPr>
  <p:slideViewPr>
    <p:cSldViewPr snapToGrid="0" snapToObjects="1">
      <p:cViewPr varScale="1">
        <p:scale>
          <a:sx n="100" d="100"/>
          <a:sy n="100" d="100"/>
        </p:scale>
        <p:origin x="228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B0EACF-48F0-5B4F-B4A1-8067BC58A3E0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606550" y="1143000"/>
            <a:ext cx="36449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5BE75B-1058-4F43-83B3-24D50C6F6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12226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606550" y="1143000"/>
            <a:ext cx="36449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5BE75B-1058-4F43-83B3-24D50C6F6AF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42954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266815"/>
            <a:ext cx="7772400" cy="2694893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4065633"/>
            <a:ext cx="6858000" cy="1868865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6605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58730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12118"/>
            <a:ext cx="1971675" cy="655984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12118"/>
            <a:ext cx="5800725" cy="655984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2459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1032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929789"/>
            <a:ext cx="7886700" cy="3219895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5180145"/>
            <a:ext cx="7886700" cy="169326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4093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060590"/>
            <a:ext cx="3886200" cy="491137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060590"/>
            <a:ext cx="3886200" cy="491137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630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12120"/>
            <a:ext cx="7886700" cy="149616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897535"/>
            <a:ext cx="3868340" cy="9299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827487"/>
            <a:ext cx="3868340" cy="415880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897535"/>
            <a:ext cx="3887391" cy="9299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827487"/>
            <a:ext cx="3887391" cy="415880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8837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7695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2574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16043"/>
            <a:ext cx="2949178" cy="180615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114512"/>
            <a:ext cx="4629150" cy="550087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322195"/>
            <a:ext cx="2949178" cy="43021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9441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16043"/>
            <a:ext cx="2949178" cy="180615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114512"/>
            <a:ext cx="4629150" cy="5500879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322195"/>
            <a:ext cx="2949178" cy="43021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6949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412120"/>
            <a:ext cx="7886700" cy="14961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060590"/>
            <a:ext cx="7886700" cy="49113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7174437"/>
            <a:ext cx="2057400" cy="4121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7174437"/>
            <a:ext cx="3086100" cy="4121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7174437"/>
            <a:ext cx="2057400" cy="4121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0719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3ABF8FF1-91A6-264A-8D04-0BE02A720AB8}"/>
              </a:ext>
            </a:extLst>
          </p:cNvPr>
          <p:cNvGrpSpPr/>
          <p:nvPr/>
        </p:nvGrpSpPr>
        <p:grpSpPr>
          <a:xfrm>
            <a:off x="1118883" y="-310124"/>
            <a:ext cx="6906234" cy="6881150"/>
            <a:chOff x="1053601" y="0"/>
            <a:chExt cx="6906234" cy="6881150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304DD8C6-EFA0-784A-8273-CB2B632F5C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107" b="6746"/>
            <a:stretch/>
          </p:blipFill>
          <p:spPr>
            <a:xfrm>
              <a:off x="1184165" y="0"/>
              <a:ext cx="6775670" cy="6858000"/>
            </a:xfrm>
            <a:prstGeom prst="rect">
              <a:avLst/>
            </a:prstGeom>
          </p:spPr>
        </p:pic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DBD1327A-9999-864E-99D7-68F5B904FC06}"/>
                </a:ext>
              </a:extLst>
            </p:cNvPr>
            <p:cNvCxnSpPr/>
            <p:nvPr/>
          </p:nvCxnSpPr>
          <p:spPr>
            <a:xfrm flipV="1">
              <a:off x="2083443" y="2777924"/>
              <a:ext cx="5370653" cy="1701479"/>
            </a:xfrm>
            <a:prstGeom prst="line">
              <a:avLst/>
            </a:prstGeom>
            <a:ln w="22225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8EE2FD41-0704-DC49-BD54-AF4DC0B36AFB}"/>
                </a:ext>
              </a:extLst>
            </p:cNvPr>
            <p:cNvSpPr txBox="1"/>
            <p:nvPr/>
          </p:nvSpPr>
          <p:spPr>
            <a:xfrm rot="16200000">
              <a:off x="-238697" y="3250994"/>
              <a:ext cx="2953927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EZH2 labelling index (%)</a:t>
              </a:r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3A4FD0CE-738F-1A4A-A6F2-F12A349A4987}"/>
                </a:ext>
              </a:extLst>
            </p:cNvPr>
            <p:cNvSpPr txBox="1"/>
            <p:nvPr/>
          </p:nvSpPr>
          <p:spPr>
            <a:xfrm>
              <a:off x="2983840" y="6511818"/>
              <a:ext cx="356985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H3K27me3 labelling index (%)</a:t>
              </a:r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1EACF095-2E4C-EF43-AA89-9E33DD696EF6}"/>
              </a:ext>
            </a:extLst>
          </p:cNvPr>
          <p:cNvSpPr/>
          <p:nvPr/>
        </p:nvSpPr>
        <p:spPr>
          <a:xfrm>
            <a:off x="783955" y="6683751"/>
            <a:ext cx="7934675" cy="7780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>
                <a:latin typeface="Arial" panose="020B0604020202020204" pitchFamily="34" charset="0"/>
                <a:ea typeface="游明朝" panose="02020400000000000000" pitchFamily="18" charset="-128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ea typeface="游明朝" panose="02020400000000000000" pitchFamily="18" charset="-128"/>
              </a:rPr>
              <a:t>2. </a:t>
            </a:r>
            <a:r>
              <a:rPr lang="en-US" altLang="ja-JP" sz="1200" dirty="0">
                <a:latin typeface="Arial" panose="020B0604020202020204" pitchFamily="34" charset="0"/>
              </a:rPr>
              <a:t>A weak positive correlation was found between the expression of EZH2 and H3K27me3 (</a:t>
            </a:r>
            <a:r>
              <a:rPr lang="en-US" altLang="ja-JP" sz="1200" i="1" dirty="0">
                <a:latin typeface="Arial" panose="020B0604020202020204" pitchFamily="34" charset="0"/>
              </a:rPr>
              <a:t>r</a:t>
            </a:r>
            <a:r>
              <a:rPr lang="en-US" altLang="ja-JP" sz="1200" dirty="0">
                <a:latin typeface="Arial" panose="020B0604020202020204" pitchFamily="34" charset="0"/>
              </a:rPr>
              <a:t> = 0.357, </a:t>
            </a:r>
            <a:r>
              <a:rPr lang="en-US" altLang="ja-JP" sz="1200" i="1" dirty="0">
                <a:latin typeface="Arial" panose="020B0604020202020204" pitchFamily="34" charset="0"/>
              </a:rPr>
              <a:t>P </a:t>
            </a:r>
            <a:r>
              <a:rPr lang="en-US" altLang="ja-JP" sz="1200" dirty="0">
                <a:latin typeface="Arial" panose="020B0604020202020204" pitchFamily="34" charset="0"/>
              </a:rPr>
              <a:t>&lt; 0.001) </a:t>
            </a:r>
            <a:endParaRPr lang="ja-JP" altLang="ja-JP" sz="1200"/>
          </a:p>
        </p:txBody>
      </p:sp>
    </p:spTree>
    <p:extLst>
      <p:ext uri="{BB962C8B-B14F-4D97-AF65-F5344CB8AC3E}">
        <p14:creationId xmlns:p14="http://schemas.microsoft.com/office/powerpoint/2010/main" val="1384414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169</TotalTime>
  <Words>35</Words>
  <Application>Microsoft Macintosh PowerPoint</Application>
  <PresentationFormat>ユーザー設定</PresentationFormat>
  <Paragraphs>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平井 秀明</dc:creator>
  <cp:lastModifiedBy>平井 秀明</cp:lastModifiedBy>
  <cp:revision>90</cp:revision>
  <dcterms:created xsi:type="dcterms:W3CDTF">2020-07-01T13:22:00Z</dcterms:created>
  <dcterms:modified xsi:type="dcterms:W3CDTF">2021-09-20T00:15:08Z</dcterms:modified>
</cp:coreProperties>
</file>